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FEDA"/>
    <a:srgbClr val="F8FDDB"/>
    <a:srgbClr val="00A44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 autoAdjust="0"/>
    <p:restoredTop sz="94628" autoAdjust="0"/>
  </p:normalViewPr>
  <p:slideViewPr>
    <p:cSldViewPr snapToGrid="0">
      <p:cViewPr varScale="1">
        <p:scale>
          <a:sx n="76" d="100"/>
          <a:sy n="76" d="100"/>
        </p:scale>
        <p:origin x="-2178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5073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1746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813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177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3816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858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2461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2572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567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089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0958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236C61-AFA0-4DC2-9C04-82538EA4E1F8}" type="datetimeFigureOut">
              <a:rPr lang="en-GB" smtClean="0"/>
              <a:t>12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DCA2B-428C-4B42-8D28-B320416DCAA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46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Rectangle 77"/>
          <p:cNvSpPr/>
          <p:nvPr/>
        </p:nvSpPr>
        <p:spPr>
          <a:xfrm>
            <a:off x="542795" y="6906005"/>
            <a:ext cx="5868000" cy="1874738"/>
          </a:xfrm>
          <a:prstGeom prst="rect">
            <a:avLst/>
          </a:prstGeom>
          <a:solidFill>
            <a:srgbClr val="F8FDDB"/>
          </a:solidFill>
          <a:ln>
            <a:solidFill>
              <a:srgbClr val="F8FDD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Rectangle 76"/>
          <p:cNvSpPr/>
          <p:nvPr/>
        </p:nvSpPr>
        <p:spPr>
          <a:xfrm>
            <a:off x="528180" y="2419608"/>
            <a:ext cx="5868000" cy="3329837"/>
          </a:xfrm>
          <a:prstGeom prst="rect">
            <a:avLst/>
          </a:prstGeom>
          <a:solidFill>
            <a:srgbClr val="F8FDDB"/>
          </a:solidFill>
          <a:ln>
            <a:solidFill>
              <a:srgbClr val="F8FDDB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/>
          <p:cNvSpPr/>
          <p:nvPr/>
        </p:nvSpPr>
        <p:spPr>
          <a:xfrm>
            <a:off x="526092" y="1853849"/>
            <a:ext cx="5868000" cy="468000"/>
          </a:xfrm>
          <a:prstGeom prst="rect">
            <a:avLst/>
          </a:prstGeom>
          <a:solidFill>
            <a:srgbClr val="E4FEDA"/>
          </a:solidFill>
          <a:ln>
            <a:solidFill>
              <a:srgbClr val="E4FED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/>
          <p:cNvSpPr txBox="1"/>
          <p:nvPr/>
        </p:nvSpPr>
        <p:spPr>
          <a:xfrm>
            <a:off x="966195" y="79565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X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238619" y="8397934"/>
            <a:ext cx="1917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GB" sz="1400" smtClean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GB" sz="1400" smtClean="0">
                <a:latin typeface="Arial" panose="020B0604020202020204" pitchFamily="34" charset="0"/>
                <a:cs typeface="Arial" panose="020B0604020202020204" pitchFamily="34" charset="0"/>
              </a:rPr>
              <a:t>A,G,V,S,T</a:t>
            </a:r>
            <a:r>
              <a:rPr lang="en-GB" sz="1400" smtClean="0">
                <a:latin typeface="Arial" panose="020B0604020202020204" pitchFamily="34" charset="0"/>
                <a:cs typeface="Arial" panose="020B0604020202020204" pitchFamily="34" charset="0"/>
              </a:rPr>
              <a:t>,(C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93765" y="7956508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1524257" y="8110396"/>
            <a:ext cx="57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2580899" y="8110396"/>
            <a:ext cx="57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126435" y="7956508"/>
            <a:ext cx="6940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X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66195" y="711215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400" b="1" dirty="0">
                <a:latin typeface="Symbol" panose="05050102010706020507" pitchFamily="18" charset="2"/>
                <a:cs typeface="Arial" panose="020B0604020202020204" pitchFamily="34" charset="0"/>
                <a:sym typeface="Symbol"/>
              </a:rPr>
              <a:t>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76339" y="7798329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tAP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00561" y="7798329"/>
            <a:ext cx="715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AT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1542259" y="7266045"/>
            <a:ext cx="1584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126435" y="7112157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M</a:t>
            </a:r>
            <a:r>
              <a:rPr lang="en-GB" sz="1400" b="1" dirty="0">
                <a:latin typeface="Symbol" panose="05050102010706020507" pitchFamily="18" charset="2"/>
                <a:cs typeface="Arial" panose="020B0604020202020204" pitchFamily="34" charset="0"/>
                <a:sym typeface="Symbol"/>
              </a:rPr>
              <a:t>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02299" y="6979174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AT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Brace 19"/>
          <p:cNvSpPr/>
          <p:nvPr/>
        </p:nvSpPr>
        <p:spPr>
          <a:xfrm>
            <a:off x="3998543" y="7006613"/>
            <a:ext cx="142875" cy="1266825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22" name="Straight Arrow Connector 21"/>
          <p:cNvCxnSpPr/>
          <p:nvPr/>
        </p:nvCxnSpPr>
        <p:spPr>
          <a:xfrm flipV="1">
            <a:off x="4236668" y="7359038"/>
            <a:ext cx="952500" cy="200027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141542" y="7194112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P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246191" y="6958988"/>
            <a:ext cx="9525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/N-recognins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141542" y="7682888"/>
            <a:ext cx="904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gron protec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4236668" y="7711463"/>
            <a:ext cx="952500" cy="200027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60018" y="6549413"/>
            <a:ext cx="2082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/N-end rule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398327" y="542427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400" b="1" dirty="0">
                <a:latin typeface="Symbol" panose="05050102010706020507" pitchFamily="18" charset="2"/>
                <a:cs typeface="Arial" panose="020B0604020202020204" pitchFamily="34" charset="0"/>
                <a:sym typeface="Symbol"/>
              </a:rPr>
              <a:t>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30289" y="340863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398327" y="203284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C*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398327" y="268659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D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398327" y="293950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398327" y="331767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398327" y="357058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398327" y="382349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-</a:t>
            </a:r>
            <a:endParaRPr lang="en-GB" sz="1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398327" y="408893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sz="14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398327" y="434184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r>
              <a:rPr lang="en-GB" sz="14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398327" y="459475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-</a:t>
            </a:r>
            <a:endParaRPr lang="en-GB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398327" y="484766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GB" sz="14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398327" y="5100571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1400" b="1" dirty="0" smtClean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380931" y="2032841"/>
            <a:ext cx="4669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*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113217" y="2032841"/>
            <a:ext cx="3812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>
            <a:off x="1218606" y="4362877"/>
            <a:ext cx="2700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ight Brace 51"/>
          <p:cNvSpPr/>
          <p:nvPr/>
        </p:nvSpPr>
        <p:spPr>
          <a:xfrm flipH="1">
            <a:off x="4173909" y="3431541"/>
            <a:ext cx="122520" cy="1908000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TextBox 53"/>
          <p:cNvSpPr txBox="1"/>
          <p:nvPr/>
        </p:nvSpPr>
        <p:spPr>
          <a:xfrm>
            <a:off x="5037420" y="3566522"/>
            <a:ext cx="10126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-recognins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857613" y="3713965"/>
            <a:ext cx="618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UP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404998" y="4020852"/>
            <a:ext cx="814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Pas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Arrow Connector 57"/>
          <p:cNvCxnSpPr/>
          <p:nvPr/>
        </p:nvCxnSpPr>
        <p:spPr>
          <a:xfrm>
            <a:off x="3793556" y="2186729"/>
            <a:ext cx="57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2598669" y="2186729"/>
            <a:ext cx="684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1376035" y="2186729"/>
            <a:ext cx="57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1215589" y="1890220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tAP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508621" y="1890220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NO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660252" y="1890220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30289" y="1970229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C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380931" y="268868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380931" y="2941597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Arrow Connector 67"/>
          <p:cNvCxnSpPr/>
          <p:nvPr/>
        </p:nvCxnSpPr>
        <p:spPr>
          <a:xfrm>
            <a:off x="3808170" y="2965429"/>
            <a:ext cx="576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3662340" y="2668920"/>
            <a:ext cx="864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T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113217" y="269077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113217" y="294368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Q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2598669" y="2980043"/>
            <a:ext cx="684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2417524" y="2683534"/>
            <a:ext cx="10462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-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idas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ight Brace 73"/>
          <p:cNvSpPr/>
          <p:nvPr/>
        </p:nvSpPr>
        <p:spPr>
          <a:xfrm flipH="1">
            <a:off x="1983940" y="2085972"/>
            <a:ext cx="145484" cy="1133215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75" name="Straight Arrow Connector 74"/>
          <p:cNvCxnSpPr/>
          <p:nvPr/>
        </p:nvCxnSpPr>
        <p:spPr>
          <a:xfrm>
            <a:off x="1215285" y="2652279"/>
            <a:ext cx="648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1267217" y="2369504"/>
            <a:ext cx="8141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Pas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1202499" y="2642990"/>
            <a:ext cx="12526" cy="172859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730289" y="5424275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1400" b="1" dirty="0">
                <a:latin typeface="Symbol" panose="05050102010706020507" pitchFamily="18" charset="2"/>
                <a:cs typeface="Arial" panose="020B0604020202020204" pitchFamily="34" charset="0"/>
                <a:sym typeface="Symbol"/>
              </a:rPr>
              <a:t>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315863" y="5982504"/>
            <a:ext cx="1917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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= L,F,Y,W,I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1371006" y="5578163"/>
            <a:ext cx="3024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560018" y="952379"/>
            <a:ext cx="23564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/N-end rule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Arrow Connector 55"/>
          <p:cNvCxnSpPr/>
          <p:nvPr/>
        </p:nvCxnSpPr>
        <p:spPr>
          <a:xfrm>
            <a:off x="5075667" y="3853635"/>
            <a:ext cx="828000" cy="0"/>
          </a:xfrm>
          <a:prstGeom prst="straightConnector1">
            <a:avLst/>
          </a:prstGeom>
          <a:ln w="1905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ight Brace 85"/>
          <p:cNvSpPr/>
          <p:nvPr/>
        </p:nvSpPr>
        <p:spPr>
          <a:xfrm>
            <a:off x="4985359" y="2136076"/>
            <a:ext cx="135177" cy="3438004"/>
          </a:xfrm>
          <a:prstGeom prst="righ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522440" y="375781"/>
            <a:ext cx="14780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496844" y="1480159"/>
            <a:ext cx="413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°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359063" y="1480159"/>
            <a:ext cx="413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°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081408" y="1480159"/>
            <a:ext cx="4133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°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2204581" y="1453019"/>
            <a:ext cx="262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497710" y="1139868"/>
            <a:ext cx="20417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stabilising residues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2563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</TotalTime>
  <Words>78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eddie Theodoulou (RRes-Roth)</dc:creator>
  <cp:lastModifiedBy>Freddie Theodoulou (RRes-Roth)</cp:lastModifiedBy>
  <cp:revision>31</cp:revision>
  <cp:lastPrinted>2014-09-05T13:59:11Z</cp:lastPrinted>
  <dcterms:created xsi:type="dcterms:W3CDTF">2014-07-18T11:40:30Z</dcterms:created>
  <dcterms:modified xsi:type="dcterms:W3CDTF">2015-01-12T15:21:01Z</dcterms:modified>
</cp:coreProperties>
</file>